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7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FF33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4" d="100"/>
          <a:sy n="74" d="100"/>
        </p:scale>
        <p:origin x="-708" y="-4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2" tIns="46586" rIns="93172" bIns="46586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2" tIns="46586" rIns="93172" bIns="46586" rtlCol="0"/>
          <a:lstStyle>
            <a:lvl1pPr algn="r">
              <a:defRPr sz="1300"/>
            </a:lvl1pPr>
          </a:lstStyle>
          <a:p>
            <a:fld id="{303FAED0-1B73-4830-A88A-6C2E89DADE30}" type="datetimeFigureOut">
              <a:rPr lang="en-US" smtClean="0"/>
              <a:pPr/>
              <a:t>12/6/201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8500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2" tIns="46586" rIns="93172" bIns="46586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2" tIns="46586" rIns="93172" bIns="46586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2" tIns="46586" rIns="93172" bIns="46586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2" tIns="46586" rIns="93172" bIns="46586" rtlCol="0" anchor="b"/>
          <a:lstStyle>
            <a:lvl1pPr algn="r">
              <a:defRPr sz="1300"/>
            </a:lvl1pPr>
          </a:lstStyle>
          <a:p>
            <a:fld id="{A2033110-34FC-4F74-B9B5-9F55471FC41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0746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EE321-5E13-4052-848B-9B0D3FF69097}" type="datetimeFigureOut">
              <a:rPr lang="en-US" smtClean="0"/>
              <a:pPr/>
              <a:t>12/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B2E24-2E2B-49D3-B30C-6B329D0825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EE321-5E13-4052-848B-9B0D3FF69097}" type="datetimeFigureOut">
              <a:rPr lang="en-US" smtClean="0"/>
              <a:pPr/>
              <a:t>12/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B2E24-2E2B-49D3-B30C-6B329D0825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EE321-5E13-4052-848B-9B0D3FF69097}" type="datetimeFigureOut">
              <a:rPr lang="en-US" smtClean="0"/>
              <a:pPr/>
              <a:t>12/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B2E24-2E2B-49D3-B30C-6B329D0825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EE321-5E13-4052-848B-9B0D3FF69097}" type="datetimeFigureOut">
              <a:rPr lang="en-US" smtClean="0"/>
              <a:pPr/>
              <a:t>12/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B2E24-2E2B-49D3-B30C-6B329D0825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EE321-5E13-4052-848B-9B0D3FF69097}" type="datetimeFigureOut">
              <a:rPr lang="en-US" smtClean="0"/>
              <a:pPr/>
              <a:t>12/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B2E24-2E2B-49D3-B30C-6B329D0825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EE321-5E13-4052-848B-9B0D3FF69097}" type="datetimeFigureOut">
              <a:rPr lang="en-US" smtClean="0"/>
              <a:pPr/>
              <a:t>12/6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B2E24-2E2B-49D3-B30C-6B329D0825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EE321-5E13-4052-848B-9B0D3FF69097}" type="datetimeFigureOut">
              <a:rPr lang="en-US" smtClean="0"/>
              <a:pPr/>
              <a:t>12/6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B2E24-2E2B-49D3-B30C-6B329D0825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EE321-5E13-4052-848B-9B0D3FF69097}" type="datetimeFigureOut">
              <a:rPr lang="en-US" smtClean="0"/>
              <a:pPr/>
              <a:t>12/6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B2E24-2E2B-49D3-B30C-6B329D0825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EE321-5E13-4052-848B-9B0D3FF69097}" type="datetimeFigureOut">
              <a:rPr lang="en-US" smtClean="0"/>
              <a:pPr/>
              <a:t>12/6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B2E24-2E2B-49D3-B30C-6B329D0825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EE321-5E13-4052-848B-9B0D3FF69097}" type="datetimeFigureOut">
              <a:rPr lang="en-US" smtClean="0"/>
              <a:pPr/>
              <a:t>12/6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B2E24-2E2B-49D3-B30C-6B329D0825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EE321-5E13-4052-848B-9B0D3FF69097}" type="datetimeFigureOut">
              <a:rPr lang="en-US" smtClean="0"/>
              <a:pPr/>
              <a:t>12/6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B2E24-2E2B-49D3-B30C-6B329D0825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0EE321-5E13-4052-848B-9B0D3FF69097}" type="datetimeFigureOut">
              <a:rPr lang="en-US" smtClean="0"/>
              <a:pPr/>
              <a:t>12/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4B2E24-2E2B-49D3-B30C-6B329D0825B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010400" y="322697"/>
            <a:ext cx="16112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Valero Table S2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1892732"/>
              </p:ext>
            </p:extLst>
          </p:nvPr>
        </p:nvGraphicFramePr>
        <p:xfrm>
          <a:off x="533400" y="914400"/>
          <a:ext cx="8153401" cy="4255897"/>
        </p:xfrm>
        <a:graphic>
          <a:graphicData uri="http://schemas.openxmlformats.org/drawingml/2006/table">
            <a:tbl>
              <a:tblPr/>
              <a:tblGrid>
                <a:gridCol w="940777"/>
                <a:gridCol w="2665535"/>
                <a:gridCol w="2665535"/>
                <a:gridCol w="940777"/>
                <a:gridCol w="940777"/>
              </a:tblGrid>
              <a:tr h="2367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ame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Forward primer (5´-3´)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20955" marR="0" indent="-20955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Reverse primer (5´-3´)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err="1">
                          <a:effectLst/>
                          <a:latin typeface="Arial"/>
                          <a:ea typeface="Calibri"/>
                          <a:cs typeface="Times New Roman"/>
                        </a:rPr>
                        <a:t>Amplicon</a:t>
                      </a:r>
                      <a:r>
                        <a:rPr lang="en-US" sz="1000" b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 size (</a:t>
                      </a:r>
                      <a:r>
                        <a:rPr lang="en-US" sz="1000" b="1" dirty="0" err="1">
                          <a:effectLst/>
                          <a:latin typeface="Arial"/>
                          <a:ea typeface="Calibri"/>
                          <a:cs typeface="Times New Roman"/>
                        </a:rPr>
                        <a:t>bp</a:t>
                      </a:r>
                      <a:r>
                        <a:rPr lang="en-US" sz="1000" b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)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810260" algn="l"/>
                          <a:tab pos="3314700" algn="l"/>
                          <a:tab pos="4743450" algn="l"/>
                        </a:tabLst>
                      </a:pPr>
                      <a:r>
                        <a:rPr lang="en-US" sz="1000" b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Annealing (°C)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67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Sca-1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TTCTCTGAGGATGGACACTTCT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GGTCTGCAGGAGGACTGAGC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406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67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D90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AGCCAACTTCACCACCAAGGATG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40385" algn="l"/>
                          <a:tab pos="810260" algn="l"/>
                          <a:tab pos="3714750" algn="l"/>
                          <a:tab pos="4140835" algn="l"/>
                          <a:tab pos="4951095" algn="l"/>
                        </a:tabLs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AAATGAAGTCCAGGGCTTGGAGG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206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67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D105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TGCCCATTACCCTGCTGTTTG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40385" algn="l"/>
                          <a:tab pos="810260" algn="l"/>
                          <a:tab pos="3714750" algn="l"/>
                          <a:tab pos="4140835" algn="l"/>
                          <a:tab pos="4951095" algn="l"/>
                        </a:tabLs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GCCATTTTGCTTGGATGCC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248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67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D73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GAAAGCCCTGGAACAGAGTG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TCTCCACCGTTGGCCAGATAG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31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5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67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</a:t>
                      </a:r>
                      <a:r>
                        <a:rPr lang="es-ES_tradnl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D29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_tradnl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TCACAAATACTGTAAGCTGTCC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_tradnl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AGCACTGTCAAAATGAAAAGGC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_tradnl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68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_tradnl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67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D31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GTCATGGCCATGGTCGAGT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TCCTCGGCGATCTTGCTGA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260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67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Pax3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GCTGTCTGTGATCGGAAC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TCTGCTCCTGCGCTGCTT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250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67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Pax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GCTGCTGAAGGACGGTCAC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Arial"/>
                          <a:ea typeface="Calibri"/>
                          <a:cs typeface="Times New Roman"/>
                        </a:rPr>
                        <a:t>TCGATGCTGTGTTTGGCTTTC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53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67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  <a:latin typeface="Arial"/>
                          <a:ea typeface="Calibri"/>
                          <a:cs typeface="Times New Roman"/>
                        </a:rPr>
                        <a:t>MyoD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Arial"/>
                          <a:ea typeface="Calibri"/>
                          <a:cs typeface="Times New Roman"/>
                        </a:rPr>
                        <a:t>GCTACCCAAGGTGGAGATCCT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Arial"/>
                          <a:ea typeface="Calibri"/>
                          <a:cs typeface="Times New Roman"/>
                        </a:rPr>
                        <a:t>GGCGGTGTCGTAGCCATT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256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67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Myf5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Arial"/>
                          <a:ea typeface="Calibri"/>
                          <a:cs typeface="Times New Roman"/>
                        </a:rPr>
                        <a:t>GAGCTGCTGAGGGAACAGGTGGAG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GTTCTTTCGGGACCAGACAGGGCTG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32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61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67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  <a:latin typeface="Arial"/>
                          <a:ea typeface="Calibri"/>
                          <a:cs typeface="Times New Roman"/>
                        </a:rPr>
                        <a:t>Myog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GGGCAATGCACTGGAGTTCG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TCAGTTGGGCATGGTTTCGTC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5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9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67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Itga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AAATCCTCCATTAAGAACTTGT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TGCCTGTCTTCTCCTCCTTG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280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8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67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D140b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GCAGCGACACTCCAACAAGC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TCACTCTCCCCAGTCAGGTTCAAG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08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61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67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Rgs5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ATTCTCCTCCAGAAGCCAGAC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AGGCAACCCAGAACTCAAG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218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67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Symbol"/>
                          <a:ea typeface="Calibri"/>
                          <a:cs typeface="Arial"/>
                          <a:sym typeface="Symbol"/>
                        </a:rPr>
                        <a:t></a:t>
                      </a:r>
                      <a:r>
                        <a:rPr lang="en-US" sz="1000" dirty="0" smtClean="0">
                          <a:effectLst/>
                          <a:latin typeface="Arial"/>
                          <a:ea typeface="Calibri"/>
                          <a:cs typeface="Times New Roman"/>
                        </a:rPr>
                        <a:t>Act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CTCTATGCCAACACAGTGC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ATCGTACTCCTGCTTGCTG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215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88</TotalTime>
  <Words>104</Words>
  <Application>Microsoft Office PowerPoint</Application>
  <PresentationFormat>On-screen Show (4:3)</PresentationFormat>
  <Paragraphs>8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tephen Boppart</dc:creator>
  <cp:lastModifiedBy>Stephen Boppart</cp:lastModifiedBy>
  <cp:revision>371</cp:revision>
  <cp:lastPrinted>2011-01-17T02:43:38Z</cp:lastPrinted>
  <dcterms:created xsi:type="dcterms:W3CDTF">2010-05-04T22:24:00Z</dcterms:created>
  <dcterms:modified xsi:type="dcterms:W3CDTF">2011-12-06T18:03:14Z</dcterms:modified>
</cp:coreProperties>
</file>